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B5272-A35B-42E2-9928-6802EC5D7EC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A5FD6-A7F3-44E2-8CA2-4A1AE7C607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013C7-B999-4D12-AFB5-8839E49259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4EE84-8F55-4631-B763-13BA72721A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89B923-EAB6-4114-BB5A-897F31346A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F82E5-4C5B-4B34-B25B-E8CD960725E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C20FCF-387E-4170-83BD-F2477CBC13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8A6AE1-2AAC-4A75-A2BA-173750F68B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65EB58-03A7-4252-9A85-DDCDB3758B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FA8E9C-0500-41C5-8718-BE0731EAC5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E4FA52-C330-4739-AB73-0F7F0F1CE1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248619-A74D-4904-8CCB-A9A90C9402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368379-ECDF-4343-B32A-36360FBE0F0D}" type="slidenum">
              <a:rPr b="0" lang="en-GB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879560" y="738360"/>
          <a:ext cx="2692440" cy="2170080"/>
        </p:xfrm>
        <a:graphic>
          <a:graphicData uri="http://schemas.openxmlformats.org/drawingml/2006/table">
            <a:tbl>
              <a:tblPr/>
              <a:tblGrid>
                <a:gridCol w="673200"/>
                <a:gridCol w="673200"/>
                <a:gridCol w="672840"/>
                <a:gridCol w="673200"/>
              </a:tblGrid>
              <a:tr h="190440">
                <a:tc gridSpan="4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 Bold"/>
                        </a:rPr>
                        <a:t>Correlation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57200"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O3a_nucl_cutoff_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K2_nucl_cutoff4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960">
                <a:tc rowSpan="3"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O3a_nucl_cutoff_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arson Correl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7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7280">
                <a:tc rowSpan="3"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K2_nucl_cutoff4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arson Correl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7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2" name=""/>
          <p:cNvGraphicFramePr/>
          <p:nvPr/>
        </p:nvGraphicFramePr>
        <p:xfrm>
          <a:off x="1879560" y="3451320"/>
          <a:ext cx="2692440" cy="2170080"/>
        </p:xfrm>
        <a:graphic>
          <a:graphicData uri="http://schemas.openxmlformats.org/drawingml/2006/table">
            <a:tbl>
              <a:tblPr/>
              <a:tblGrid>
                <a:gridCol w="673200"/>
                <a:gridCol w="673200"/>
                <a:gridCol w="672840"/>
                <a:gridCol w="673200"/>
              </a:tblGrid>
              <a:tr h="190440">
                <a:tc gridSpan="4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 Bold"/>
                        </a:rPr>
                        <a:t>Correlation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57200"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K2_nucl_cutoff4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O3a_total_cutoff_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960">
                <a:tc rowSpan="3"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K2_nucl_cutoff4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arson Correl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2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7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.0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00"/>
                    </a:solidFill>
                  </a:tcPr>
                </a:tc>
              </a:tr>
              <a:tr h="1778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7640">
                <a:tc rowSpan="3"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O3a_total_cutoff_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arson Correl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23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7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0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1879560" y="6135840"/>
          <a:ext cx="2692440" cy="2168280"/>
        </p:xfrm>
        <a:graphic>
          <a:graphicData uri="http://schemas.openxmlformats.org/drawingml/2006/table">
            <a:tbl>
              <a:tblPr/>
              <a:tblGrid>
                <a:gridCol w="673200"/>
                <a:gridCol w="673200"/>
                <a:gridCol w="672840"/>
                <a:gridCol w="673200"/>
              </a:tblGrid>
              <a:tr h="190440">
                <a:tc gridSpan="4">
                  <a:txBody>
                    <a:bodyPr lIns="12600" rIns="12600" tIns="126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 Bold"/>
                        </a:rPr>
                        <a:t>Correlation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57200">
                <a:tc gridSpan="2">
                  <a:txBody>
                    <a:bodyPr lIns="12600" rIns="12600" tIns="1260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O3a_total_cutoff_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K2_total_cutoff7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91960">
                <a:tc rowSpan="3"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O3a_total_cutoff_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arson Correl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7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3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640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87280">
                <a:tc rowSpan="3"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OXK2_total_cutoff7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earson Correlatio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1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87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ig. (2-tailed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.3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2600" rIns="12600" tIns="126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12600" marR="1260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9360">
                      <a:solidFill>
                        <a:srgbClr val="000000"/>
                      </a:solidFill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12600" rIns="12600" tIns="12600" bIns="0" anchor="ctr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2600" marR="12600">
                    <a:lnL w="2880">
                      <a:solidFill>
                        <a:srgbClr val="000000"/>
                      </a:solidFill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TextBox 6"/>
          <p:cNvSpPr/>
          <p:nvPr/>
        </p:nvSpPr>
        <p:spPr>
          <a:xfrm>
            <a:off x="1848240" y="507960"/>
            <a:ext cx="3745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Cytoplasmic FOXK2 and Total FOXO3a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7"/>
          <p:cNvSpPr/>
          <p:nvPr/>
        </p:nvSpPr>
        <p:spPr>
          <a:xfrm>
            <a:off x="1847160" y="3144960"/>
            <a:ext cx="3340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Nuclear FOXK2 and Total FOXO3a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8"/>
          <p:cNvSpPr/>
          <p:nvPr/>
        </p:nvSpPr>
        <p:spPr>
          <a:xfrm>
            <a:off x="1794240" y="5791320"/>
            <a:ext cx="3089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otal FOXK2 and Total FOXO3a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6"/>
          <p:cNvSpPr/>
          <p:nvPr/>
        </p:nvSpPr>
        <p:spPr>
          <a:xfrm>
            <a:off x="4933440" y="8793000"/>
            <a:ext cx="1915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9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2T14:16:50Z</dcterms:created>
  <dc:creator>gn912</dc:creator>
  <dc:description/>
  <dc:language>en-US</dc:language>
  <cp:lastModifiedBy>Eric Lam</cp:lastModifiedBy>
  <dcterms:modified xsi:type="dcterms:W3CDTF">2015-07-22T12:37:48Z</dcterms:modified>
  <cp:revision>201</cp:revision>
  <dc:subject/>
  <dc:title>PowerPoint Presentation</dc:title>
</cp:coreProperties>
</file>